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29EA40-49CF-41D3-97F2-55B62879AA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531236-A3A5-42BE-95BE-A105DB0E13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3BD355-D792-4F1C-9AA8-6FC71236A9E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A4953-BF22-4E44-8EE8-18AB736E35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DE91ED-BE83-425C-B408-93B112C987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FAE20-930C-42E8-9053-A7ACB128FD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8A4D9A-E625-4A5C-991C-844562CF2D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94D9EB-D612-42B9-85E6-C135EAB8BB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B864D-FE4D-4BD7-89B5-330ABE9DB2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BF1A74-4084-48E0-BCB8-1DB64D2E66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72882C-A842-4B22-896C-A6D4DCA2BC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ED609-789E-4B1F-9087-D43941D24F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DCB637-70FC-43AD-825A-88399E4545CC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5"/>
          <p:cNvSpPr/>
          <p:nvPr/>
        </p:nvSpPr>
        <p:spPr>
          <a:xfrm>
            <a:off x="693720" y="3203640"/>
            <a:ext cx="5472000" cy="95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Book Antiqua"/>
              </a:rPr>
              <a:t>Normal distribution of the R values (RQ</a:t>
            </a:r>
            <a:r>
              <a:rPr b="0" lang="en-GB" sz="1100" spc="-1" strike="noStrike" baseline="-25000">
                <a:solidFill>
                  <a:srgbClr val="000000"/>
                </a:solidFill>
                <a:latin typeface="Book Antiqua"/>
              </a:rPr>
              <a:t>HCC</a:t>
            </a:r>
            <a:r>
              <a:rPr b="0" lang="en-GB" sz="1100" spc="-1" strike="noStrike">
                <a:solidFill>
                  <a:srgbClr val="000000"/>
                </a:solidFill>
                <a:latin typeface="Book Antiqua"/>
              </a:rPr>
              <a:t>/RQ</a:t>
            </a:r>
            <a:r>
              <a:rPr b="0" lang="en-GB" sz="1100" spc="-1" strike="noStrike" baseline="-25000">
                <a:solidFill>
                  <a:srgbClr val="000000"/>
                </a:solidFill>
                <a:latin typeface="Book Antiqua"/>
              </a:rPr>
              <a:t>PT</a:t>
            </a:r>
            <a:r>
              <a:rPr b="0" lang="en-GB" sz="1100" spc="-1" strike="noStrike">
                <a:solidFill>
                  <a:srgbClr val="000000"/>
                </a:solidFill>
                <a:latin typeface="Book Antiqua"/>
              </a:rPr>
              <a:t>) of miR-193a detected by real-time PCR in tissues from biopsy specimens from patients affected by HCC. The black curve indicates the normal distribution of R in all cases tested; the dashed black and grey curves refer to the HCC samples with, respectively, the presence or absence of liver cirrhosis as background disease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uppo 14"/>
          <p:cNvGrpSpPr/>
          <p:nvPr/>
        </p:nvGrpSpPr>
        <p:grpSpPr>
          <a:xfrm>
            <a:off x="765000" y="250920"/>
            <a:ext cx="5338800" cy="2705040"/>
            <a:chOff x="765000" y="250920"/>
            <a:chExt cx="5338800" cy="2705040"/>
          </a:xfrm>
        </p:grpSpPr>
        <p:grpSp>
          <p:nvGrpSpPr>
            <p:cNvPr id="43" name="Gruppo 12"/>
            <p:cNvGrpSpPr/>
            <p:nvPr/>
          </p:nvGrpSpPr>
          <p:grpSpPr>
            <a:xfrm>
              <a:off x="765000" y="250920"/>
              <a:ext cx="5338800" cy="2705040"/>
              <a:chOff x="765000" y="250920"/>
              <a:chExt cx="5338800" cy="2705040"/>
            </a:xfrm>
          </p:grpSpPr>
          <p:grpSp>
            <p:nvGrpSpPr>
              <p:cNvPr id="44" name="Gruppo 7"/>
              <p:cNvGrpSpPr/>
              <p:nvPr/>
            </p:nvGrpSpPr>
            <p:grpSpPr>
              <a:xfrm>
                <a:off x="765000" y="250920"/>
                <a:ext cx="5338800" cy="2705040"/>
                <a:chOff x="765000" y="250920"/>
                <a:chExt cx="5338800" cy="2705040"/>
              </a:xfrm>
            </p:grpSpPr>
            <p:graphicFrame>
              <p:nvGraphicFramePr>
                <p:cNvPr id="45" name="Object 5"/>
                <p:cNvGraphicFramePr/>
                <p:nvPr/>
              </p:nvGraphicFramePr>
              <p:xfrm>
                <a:off x="765000" y="250920"/>
                <a:ext cx="5338800" cy="2705040"/>
              </p:xfrm>
              <a:graphic>
                <a:graphicData uri="http://schemas.openxmlformats.org/presentationml/2006/ole">
                  <p:oleObj r:id="rId1" spid="">
                    <p:embed/>
                    <p:pic>
                      <p:nvPicPr>
                        <p:cNvPr id="46" name="Object 5" descr=""/>
                        <p:cNvPicPr/>
                        <p:nvPr/>
                      </p:nvPicPr>
                      <p:blipFill>
                        <a:blip r:embed="rId2"/>
                        <a:stretch/>
                      </p:blipFill>
                      <p:spPr>
                        <a:xfrm>
                          <a:off x="765000" y="250920"/>
                          <a:ext cx="5338800" cy="270504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sp>
              <p:nvSpPr>
                <p:cNvPr id="47" name="Rectangle 6"/>
                <p:cNvSpPr/>
                <p:nvPr/>
              </p:nvSpPr>
              <p:spPr>
                <a:xfrm>
                  <a:off x="4797360" y="1258920"/>
                  <a:ext cx="1224000" cy="7189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Text Box 7"/>
                <p:cNvSpPr/>
                <p:nvPr/>
              </p:nvSpPr>
              <p:spPr>
                <a:xfrm>
                  <a:off x="4797360" y="1548000"/>
                  <a:ext cx="1225440" cy="60228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37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600" spc="-1" strike="noStrike">
                      <a:solidFill>
                        <a:srgbClr val="000000"/>
                      </a:solidFill>
                      <a:latin typeface="Calibri"/>
                    </a:rPr>
                    <a:t>R              SEM          P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spcBef>
                      <a:spcPts val="37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600" spc="-1" strike="noStrike">
                      <a:solidFill>
                        <a:srgbClr val="000000"/>
                      </a:solidFill>
                      <a:latin typeface="Calibri"/>
                    </a:rPr>
                    <a:t>0.700        0.098        0.00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spcBef>
                      <a:spcPts val="37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600" spc="-1" strike="noStrike">
                      <a:solidFill>
                        <a:srgbClr val="000000"/>
                      </a:solidFill>
                      <a:latin typeface="Calibri"/>
                    </a:rPr>
                    <a:t>0.644        0.116        0.005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spcBef>
                      <a:spcPts val="374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600" spc="-1" strike="noStrike">
                      <a:solidFill>
                        <a:srgbClr val="000000"/>
                      </a:solidFill>
                      <a:latin typeface="Calibri"/>
                    </a:rPr>
                    <a:t>0.801        0.179        0.28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Connettore 1 9"/>
                <p:cNvSpPr/>
                <p:nvPr/>
              </p:nvSpPr>
              <p:spPr>
                <a:xfrm flipV="1">
                  <a:off x="2892240" y="684000"/>
                  <a:ext cx="0" cy="1836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Rettangolo 6"/>
                <p:cNvSpPr/>
                <p:nvPr/>
              </p:nvSpPr>
              <p:spPr>
                <a:xfrm>
                  <a:off x="1196640" y="2586240"/>
                  <a:ext cx="3095640" cy="712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4480" bIns="2448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1" name="CasellaDiTesto 8"/>
              <p:cNvSpPr/>
              <p:nvPr/>
            </p:nvSpPr>
            <p:spPr>
              <a:xfrm>
                <a:off x="1211400" y="2517840"/>
                <a:ext cx="3456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0.8                     0.0                     0.8   1.0              1.6                     2.4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ttangolo 11"/>
              <p:cNvSpPr/>
              <p:nvPr/>
            </p:nvSpPr>
            <p:spPr>
              <a:xfrm>
                <a:off x="1168200" y="684000"/>
                <a:ext cx="107640" cy="1943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3" name="CasellaDiTesto 13"/>
            <p:cNvSpPr/>
            <p:nvPr/>
          </p:nvSpPr>
          <p:spPr>
            <a:xfrm>
              <a:off x="1075680" y="717480"/>
              <a:ext cx="288000" cy="1870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it-IT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it-IT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it-IT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it-IT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1" lang="it-IT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CasellaDiTesto 13"/>
          <p:cNvSpPr/>
          <p:nvPr/>
        </p:nvSpPr>
        <p:spPr>
          <a:xfrm>
            <a:off x="5157720" y="8686800"/>
            <a:ext cx="194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Book Antiqua"/>
              </a:rPr>
              <a:t>Additional file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21T10:16:11Z</dcterms:created>
  <dc:creator>salvi</dc:creator>
  <dc:description/>
  <dc:language>en-US</dc:language>
  <cp:lastModifiedBy>salvi</cp:lastModifiedBy>
  <dcterms:modified xsi:type="dcterms:W3CDTF">2013-03-26T14:23:18Z</dcterms:modified>
  <cp:revision>6</cp:revision>
  <dc:subject/>
  <dc:title>Diapositiva 1</dc:title>
</cp:coreProperties>
</file>